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406BB9-5DB7-4CD7-B078-A11ECDD5357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EE39D9-884A-468F-8A16-1FAE9187C61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9CFD94-FC8C-4C2F-8582-EC5864AB5BC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E591C6-BBCE-4B65-A594-2E8BB8502AB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47BAAB-D4DE-4671-9029-F05F4E8C01B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65B7F7-137C-4284-B03F-897C98E53FC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42EB7D-C28A-4BD0-B764-63E54795797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4BE2C5-C68C-4D37-AAF3-7E41A7413D2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061E12-CA58-470B-97EC-6A819E047D8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547943-13B0-4CB8-92F2-FD15DFAF75C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6AE5B0-887F-4EA1-9C7B-3BCB3CB6733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F88C2E-0E10-47FE-BA3E-8FD467527EF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1D8EDB5-2EBE-4629-85F1-68E76C67BCF1}" type="slidenum">
              <a:rPr b="0" lang="it-IT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549440" y="2133720"/>
          <a:ext cx="6527880" cy="3047760"/>
        </p:xfrm>
        <a:graphic>
          <a:graphicData uri="http://schemas.openxmlformats.org/drawingml/2006/table">
            <a:tbl>
              <a:tblPr/>
              <a:tblGrid>
                <a:gridCol w="1549440"/>
                <a:gridCol w="4978440"/>
              </a:tblGrid>
              <a:tr h="1904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AV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aveolin 1, caveolae protein, 22kD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04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KSG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poptosis inhibito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04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IF1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ypoxia-inducible factor 1, alpha subunit (basic helix-loop-helix transcription factor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04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OXB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omeobox B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08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OXB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omeobox B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04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OXB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omeobox B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04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OXB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omeobox B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04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G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ung cancer metastasis-associated protei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04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P2K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itogen-activated protein kinase kinase 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04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ME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on-metastatic cells 2, protein (NM23B) expressed i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08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SME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oteasome (prosome, macropain) activator subunit 2 (PA28 beta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04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PS1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ibosomal protein S1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04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PS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ibosomal protein S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04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PS2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ibosomal protein S27 (metallopanstimulin 1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04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BE2H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biquitin-conjugating enzyme E2H (UBC8 homolog, yeast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04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VIM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vimenti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Title 1"/>
          <p:cNvSpPr/>
          <p:nvPr/>
        </p:nvSpPr>
        <p:spPr>
          <a:xfrm>
            <a:off x="0" y="-36360"/>
            <a:ext cx="2830680" cy="688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 table 3 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5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1-06T09:35:09Z</dcterms:created>
  <dc:creator>Admin</dc:creator>
  <dc:description/>
  <dc:language>en-US</dc:language>
  <cp:lastModifiedBy>Nome utente</cp:lastModifiedBy>
  <dcterms:modified xsi:type="dcterms:W3CDTF">2011-05-23T13:09:10Z</dcterms:modified>
  <cp:revision>256</cp:revision>
  <dc:subject/>
  <dc:title>Diapositiva 1</dc:title>
</cp:coreProperties>
</file>